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8" d="100"/>
          <a:sy n="98" d="100"/>
        </p:scale>
        <p:origin x="276" y="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FF4C82D-F8E4-4393-9D4C-AEBD8A9D00C5}" type="datetimeFigureOut">
              <a:rPr lang="en-IE" smtClean="0"/>
              <a:t>05/09/2018</a:t>
            </a:fld>
            <a:endParaRPr lang="en-I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3564584-3969-4803-AAA5-51CFA1BC121A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4048176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3564584-3969-4803-AAA5-51CFA1BC121A}" type="slidenum">
              <a:rPr lang="en-IE" smtClean="0"/>
              <a:t>1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5947781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2E1E0-8897-4BB6-BABC-75A594CB7A62}" type="datetimeFigureOut">
              <a:rPr lang="en-IE" smtClean="0"/>
              <a:t>05/09/2018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62FAA-FEDE-4F3B-A195-B4EA6B18D89B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2034826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2E1E0-8897-4BB6-BABC-75A594CB7A62}" type="datetimeFigureOut">
              <a:rPr lang="en-IE" smtClean="0"/>
              <a:t>05/09/2018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62FAA-FEDE-4F3B-A195-B4EA6B18D89B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9595120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2E1E0-8897-4BB6-BABC-75A594CB7A62}" type="datetimeFigureOut">
              <a:rPr lang="en-IE" smtClean="0"/>
              <a:t>05/09/2018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62FAA-FEDE-4F3B-A195-B4EA6B18D89B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195102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2E1E0-8897-4BB6-BABC-75A594CB7A62}" type="datetimeFigureOut">
              <a:rPr lang="en-IE" smtClean="0"/>
              <a:t>05/09/2018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62FAA-FEDE-4F3B-A195-B4EA6B18D89B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0948079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2E1E0-8897-4BB6-BABC-75A594CB7A62}" type="datetimeFigureOut">
              <a:rPr lang="en-IE" smtClean="0"/>
              <a:t>05/09/2018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62FAA-FEDE-4F3B-A195-B4EA6B18D89B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7671261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2E1E0-8897-4BB6-BABC-75A594CB7A62}" type="datetimeFigureOut">
              <a:rPr lang="en-IE" smtClean="0"/>
              <a:t>05/09/2018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62FAA-FEDE-4F3B-A195-B4EA6B18D89B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7041586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2E1E0-8897-4BB6-BABC-75A594CB7A62}" type="datetimeFigureOut">
              <a:rPr lang="en-IE" smtClean="0"/>
              <a:t>05/09/2018</a:t>
            </a:fld>
            <a:endParaRPr lang="en-I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62FAA-FEDE-4F3B-A195-B4EA6B18D89B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4048026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2E1E0-8897-4BB6-BABC-75A594CB7A62}" type="datetimeFigureOut">
              <a:rPr lang="en-IE" smtClean="0"/>
              <a:t>05/09/2018</a:t>
            </a:fld>
            <a:endParaRPr lang="en-I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62FAA-FEDE-4F3B-A195-B4EA6B18D89B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837202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2E1E0-8897-4BB6-BABC-75A594CB7A62}" type="datetimeFigureOut">
              <a:rPr lang="en-IE" smtClean="0"/>
              <a:t>05/09/2018</a:t>
            </a:fld>
            <a:endParaRPr lang="en-I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62FAA-FEDE-4F3B-A195-B4EA6B18D89B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2196343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2E1E0-8897-4BB6-BABC-75A594CB7A62}" type="datetimeFigureOut">
              <a:rPr lang="en-IE" smtClean="0"/>
              <a:t>05/09/2018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62FAA-FEDE-4F3B-A195-B4EA6B18D89B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4796914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2E1E0-8897-4BB6-BABC-75A594CB7A62}" type="datetimeFigureOut">
              <a:rPr lang="en-IE" smtClean="0"/>
              <a:t>05/09/2018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62FAA-FEDE-4F3B-A195-B4EA6B18D89B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6090310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02E1E0-8897-4BB6-BABC-75A594CB7A62}" type="datetimeFigureOut">
              <a:rPr lang="en-IE" smtClean="0"/>
              <a:t>05/09/2018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262FAA-FEDE-4F3B-A195-B4EA6B18D89B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42580651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51519" y="2861661"/>
            <a:ext cx="323165" cy="138499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IE" sz="900" dirty="0" smtClean="0"/>
              <a:t>Log2 protein intensity</a:t>
            </a:r>
            <a:endParaRPr lang="en-IE" sz="900" dirty="0"/>
          </a:p>
        </p:txBody>
      </p:sp>
      <p:sp>
        <p:nvSpPr>
          <p:cNvPr id="5" name="TextBox 4"/>
          <p:cNvSpPr txBox="1"/>
          <p:nvPr/>
        </p:nvSpPr>
        <p:spPr>
          <a:xfrm>
            <a:off x="827584" y="1124744"/>
            <a:ext cx="7848872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600" dirty="0" smtClean="0"/>
              <a:t>Supplementary </a:t>
            </a:r>
            <a:r>
              <a:rPr lang="en-IE" sz="1600" smtClean="0"/>
              <a:t>Figure </a:t>
            </a:r>
            <a:r>
              <a:rPr lang="en-IE" sz="1600" smtClean="0"/>
              <a:t>1: </a:t>
            </a:r>
            <a:r>
              <a:rPr lang="en-IE" sz="1600" dirty="0" smtClean="0"/>
              <a:t>Profile plots represent the log 2 transformed protein intensity levels (y-axis) for each protein quantified in each sample (x-axis). Overlaying box plots represent the overall distribution and median protein expression for each of the 64 cases and 67 controls profiled in the PE study. </a:t>
            </a:r>
            <a:endParaRPr lang="en-IE" sz="1600" dirty="0"/>
          </a:p>
        </p:txBody>
      </p:sp>
      <p:pic>
        <p:nvPicPr>
          <p:cNvPr id="1030" name="Picture 6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806" t="30251" r="7761" b="34378"/>
          <a:stretch/>
        </p:blipFill>
        <p:spPr bwMode="auto">
          <a:xfrm>
            <a:off x="574684" y="2545235"/>
            <a:ext cx="8461812" cy="201784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7042660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57</Words>
  <Application>Microsoft Office PowerPoint</Application>
  <PresentationFormat>On-screen Show (4:3)</PresentationFormat>
  <Paragraphs>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College Dubli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phie Sabherwal</dc:creator>
  <cp:lastModifiedBy>Melanie Focking MSc ,PhD</cp:lastModifiedBy>
  <cp:revision>7</cp:revision>
  <dcterms:created xsi:type="dcterms:W3CDTF">2017-08-24T12:35:17Z</dcterms:created>
  <dcterms:modified xsi:type="dcterms:W3CDTF">2018-09-05T13:26:02Z</dcterms:modified>
</cp:coreProperties>
</file>